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98"/>
    <p:restoredTop sz="94574"/>
  </p:normalViewPr>
  <p:slideViewPr>
    <p:cSldViewPr snapToGrid="0" snapToObjects="1" showGuides="1">
      <p:cViewPr varScale="1">
        <p:scale>
          <a:sx n="91" d="100"/>
          <a:sy n="91" d="100"/>
        </p:scale>
        <p:origin x="200" y="70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EBFB23-8B90-1C4C-83A6-A560B664F6BD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744DF7-7E64-6D46-9343-46E4DBCD06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56251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D744DF7-7E64-6D46-9343-46E4DBCD06E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6214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780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6589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92996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549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067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201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965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8592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46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669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770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2C297F-37A9-0044-8DB2-33136E330E77}" type="datetimeFigureOut">
              <a:rPr kumimoji="1" lang="ja-JP" altLang="en-US" smtClean="0"/>
              <a:t>2018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96EE7-75F8-5241-9DA8-165D6193B9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1369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71D9888-CC33-644F-8FED-2A74310EED60}"/>
              </a:ext>
            </a:extLst>
          </p:cNvPr>
          <p:cNvSpPr/>
          <p:nvPr/>
        </p:nvSpPr>
        <p:spPr>
          <a:xfrm>
            <a:off x="546411" y="1370593"/>
            <a:ext cx="31290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12239042-7868-AB42-A5BF-DBBBFA527A23}"/>
              </a:ext>
            </a:extLst>
          </p:cNvPr>
          <p:cNvSpPr/>
          <p:nvPr/>
        </p:nvSpPr>
        <p:spPr>
          <a:xfrm>
            <a:off x="5085482" y="1370593"/>
            <a:ext cx="32573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dirty="0"/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B42EB60E-54FC-DD48-BFB4-747EB59618EB}"/>
              </a:ext>
            </a:extLst>
          </p:cNvPr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815"/>
          <a:stretch/>
        </p:blipFill>
        <p:spPr bwMode="auto">
          <a:xfrm>
            <a:off x="5063181" y="1670674"/>
            <a:ext cx="4382550" cy="3069102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98DF9FD-BBA7-9B46-8AC5-8D2E18039D4E}"/>
              </a:ext>
            </a:extLst>
          </p:cNvPr>
          <p:cNvSpPr txBox="1"/>
          <p:nvPr/>
        </p:nvSpPr>
        <p:spPr>
          <a:xfrm>
            <a:off x="929312" y="5596259"/>
            <a:ext cx="801108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: Figure S4. Forest plot of 1-year (a) and 2-year (b) OS with doxorubicin alone vs experimental chemotherapy.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bbreviations: CI, confidence interval; M-H, Mantel-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Haenszel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; OS, overall survival</a:t>
            </a:r>
            <a:endParaRPr lang="ja-JP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E3CB86EA-E976-904D-A50C-A0BE96AF2A92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237"/>
          <a:stretch/>
        </p:blipFill>
        <p:spPr bwMode="auto">
          <a:xfrm>
            <a:off x="546411" y="1670674"/>
            <a:ext cx="4388441" cy="3213015"/>
          </a:xfrm>
          <a:prstGeom prst="rect">
            <a:avLst/>
          </a:prstGeom>
          <a:solidFill>
            <a:schemeClr val="bg1"/>
          </a:solidFill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924437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45</Words>
  <Application>Microsoft Macintosh PowerPoint</Application>
  <PresentationFormat>A4 210 x 297 mm</PresentationFormat>
  <Paragraphs>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/>
  <cp:lastModifiedBy>田仲和宏</cp:lastModifiedBy>
  <cp:revision>38</cp:revision>
  <cp:lastPrinted>2018-06-08T06:33:36Z</cp:lastPrinted>
  <dcterms:created xsi:type="dcterms:W3CDTF">2018-05-19T00:24:53Z</dcterms:created>
  <dcterms:modified xsi:type="dcterms:W3CDTF">2018-12-11T05:04:07Z</dcterms:modified>
</cp:coreProperties>
</file>